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2" name="AutoShape 1"/>
          <p:cNvSpPr/>
          <p:nvPr/>
        </p:nvSpPr>
        <p:spPr>
          <a:xfrm>
            <a:off x="0" y="0"/>
            <a:ext cx="7010280" cy="9296280"/>
          </a:xfrm>
          <a:custGeom>
            <a:avLst/>
            <a:gdLst>
              <a:gd name="textAreaLeft" fmla="*/ 360 w 7010280"/>
              <a:gd name="textAreaRight" fmla="*/ 7009920 w 7010280"/>
              <a:gd name="textAreaTop" fmla="*/ 360 h 9296280"/>
              <a:gd name="textAreaBottom" fmla="*/ 9295920 h 9296280"/>
            </a:gdLst>
            <a:ahLst/>
            <a:rect l="textAreaLeft" t="textAreaTop" r="textAreaRight" b="textAreaBottom"/>
            <a:pathLst>
              <a:path w="21600" h="28643">
                <a:moveTo>
                  <a:pt x="5" y="0"/>
                </a:moveTo>
                <a:arcTo wR="5" hR="5" stAng="16200000" swAng="-5400000"/>
                <a:lnTo>
                  <a:pt x="0" y="28638"/>
                </a:lnTo>
                <a:arcTo wR="5" hR="5" stAng="10800000" swAng="-5400000"/>
                <a:lnTo>
                  <a:pt x="21595" y="28643"/>
                </a:lnTo>
                <a:arcTo wR="5" hR="5" stAng="5400000" swAng="-5400000"/>
                <a:lnTo>
                  <a:pt x="21600" y="5"/>
                </a:lnTo>
                <a:arcTo wR="5" hR="5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3" name="AutoShape 2"/>
          <p:cNvSpPr/>
          <p:nvPr/>
        </p:nvSpPr>
        <p:spPr>
          <a:xfrm>
            <a:off x="0" y="0"/>
            <a:ext cx="7010280" cy="9296280"/>
          </a:xfrm>
          <a:custGeom>
            <a:avLst/>
            <a:gdLst>
              <a:gd name="textAreaLeft" fmla="*/ 360 w 7010280"/>
              <a:gd name="textAreaRight" fmla="*/ 7009920 w 7010280"/>
              <a:gd name="textAreaTop" fmla="*/ 360 h 9296280"/>
              <a:gd name="textAreaBottom" fmla="*/ 9295920 h 9296280"/>
            </a:gdLst>
            <a:ahLst/>
            <a:rect l="textAreaLeft" t="textAreaTop" r="textAreaRight" b="textAreaBottom"/>
            <a:pathLst>
              <a:path w="21600" h="28643">
                <a:moveTo>
                  <a:pt x="5" y="0"/>
                </a:moveTo>
                <a:arcTo wR="5" hR="5" stAng="16200000" swAng="-5400000"/>
                <a:lnTo>
                  <a:pt x="0" y="28638"/>
                </a:lnTo>
                <a:arcTo wR="5" hR="5" stAng="10800000" swAng="-5400000"/>
                <a:lnTo>
                  <a:pt x="21595" y="28643"/>
                </a:lnTo>
                <a:arcTo wR="5" hR="5" stAng="5400000" swAng="-5400000"/>
                <a:lnTo>
                  <a:pt x="21600" y="5"/>
                </a:lnTo>
                <a:arcTo wR="5" hR="5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4" name="Text Box 3"/>
          <p:cNvSpPr/>
          <p:nvPr/>
        </p:nvSpPr>
        <p:spPr>
          <a:xfrm>
            <a:off x="0" y="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5" name="PlaceHolder 1"/>
          <p:cNvSpPr>
            <a:spLocks noGrp="1"/>
          </p:cNvSpPr>
          <p:nvPr>
            <p:ph type="dt" idx="2"/>
          </p:nvPr>
        </p:nvSpPr>
        <p:spPr>
          <a:xfrm>
            <a:off x="3970080" y="-360"/>
            <a:ext cx="3035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 type="sldImg"/>
          </p:nvPr>
        </p:nvSpPr>
        <p:spPr>
          <a:xfrm>
            <a:off x="1181160" y="696600"/>
            <a:ext cx="4643280" cy="348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3"/>
          <p:cNvSpPr>
            <a:spLocks noGrp="1"/>
          </p:cNvSpPr>
          <p:nvPr>
            <p:ph type="body"/>
          </p:nvPr>
        </p:nvSpPr>
        <p:spPr>
          <a:xfrm>
            <a:off x="701640" y="4416120"/>
            <a:ext cx="5603760" cy="4181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Text Box 7"/>
          <p:cNvSpPr/>
          <p:nvPr/>
        </p:nvSpPr>
        <p:spPr>
          <a:xfrm>
            <a:off x="0" y="883116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9" name="PlaceHolder 4"/>
          <p:cNvSpPr>
            <a:spLocks noGrp="1"/>
          </p:cNvSpPr>
          <p:nvPr>
            <p:ph type="sldNum" idx="3"/>
          </p:nvPr>
        </p:nvSpPr>
        <p:spPr>
          <a:xfrm>
            <a:off x="3970080" y="8831160"/>
            <a:ext cx="3035160" cy="462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  <a:ea typeface="DejaVu Sans"/>
              </a:defRPr>
            </a:lvl1pPr>
          </a:lstStyle>
          <a:p>
            <a:pPr indent="0" algn="r"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E5917138-19FD-4A0B-BF93-A1A834317747}" type="slidenum">
              <a:rPr b="0" lang="en-US" sz="12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Rectangle 8"/>
          <p:cNvSpPr/>
          <p:nvPr/>
        </p:nvSpPr>
        <p:spPr>
          <a:xfrm>
            <a:off x="3970440" y="8831160"/>
            <a:ext cx="3035160" cy="46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85DC8EAE-E2B5-451D-B527-0D3901CE1A30}" type="slidenum">
              <a:rPr b="0" lang="en-US" sz="1200" spc="-1" strike="noStrike">
                <a:solidFill>
                  <a:srgbClr val="000000"/>
                </a:solidFill>
                <a:latin typeface="Times New Roman"/>
                <a:ea typeface="Droid Sans Fallback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3" name="Text Box 1"/>
          <p:cNvSpPr/>
          <p:nvPr/>
        </p:nvSpPr>
        <p:spPr>
          <a:xfrm>
            <a:off x="3970440" y="883116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0E958917-B52F-4AA9-9FDA-37EBA15EF1A0}" type="slidenum">
              <a:rPr b="0" lang="en-US" sz="1200" spc="-1" strike="noStrike">
                <a:solidFill>
                  <a:srgbClr val="000000"/>
                </a:solidFill>
                <a:latin typeface="Times New Roman"/>
                <a:ea typeface="Droid Sans Fallback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4" name="PlaceHolder 1"/>
          <p:cNvSpPr>
            <a:spLocks noGrp="1"/>
          </p:cNvSpPr>
          <p:nvPr>
            <p:ph type="sldImg"/>
          </p:nvPr>
        </p:nvSpPr>
        <p:spPr>
          <a:xfrm>
            <a:off x="1181160" y="70632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95" name="PlaceHolder 2"/>
          <p:cNvSpPr>
            <a:spLocks noGrp="1"/>
          </p:cNvSpPr>
          <p:nvPr>
            <p:ph type="body"/>
          </p:nvPr>
        </p:nvSpPr>
        <p:spPr>
          <a:xfrm>
            <a:off x="701640" y="4414680"/>
            <a:ext cx="5608800" cy="418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  <a:ea typeface="Droid Sans Fallback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FF49EC7-E0AD-4872-989F-803ECED3BF8C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440" y="609120"/>
            <a:ext cx="7769160" cy="114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440" y="1981080"/>
            <a:ext cx="77691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440" y="4129920"/>
            <a:ext cx="77691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D3E1FB2-5425-4934-BE45-064DCBD5AC52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440" y="609120"/>
            <a:ext cx="7769160" cy="114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440" y="1981080"/>
            <a:ext cx="37911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6680" y="1981080"/>
            <a:ext cx="37911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440" y="4129920"/>
            <a:ext cx="37911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6680" y="4129920"/>
            <a:ext cx="37911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C43DB40-3E26-4F69-89E5-938595D18CC3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440" y="609120"/>
            <a:ext cx="7769160" cy="114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440" y="1981080"/>
            <a:ext cx="25012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2000" y="1981080"/>
            <a:ext cx="25012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38920" y="1981080"/>
            <a:ext cx="25012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440" y="4129920"/>
            <a:ext cx="25012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2000" y="4129920"/>
            <a:ext cx="25012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38920" y="4129920"/>
            <a:ext cx="25012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1584B45-88D5-46AF-A3BA-B36A3E97A712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440" y="609120"/>
            <a:ext cx="7769160" cy="114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440" y="1981080"/>
            <a:ext cx="7769160" cy="4113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DA3BB67-5243-48E3-BBED-013657284F70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440" y="609120"/>
            <a:ext cx="7769160" cy="114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440" y="1981080"/>
            <a:ext cx="776916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46C27E4-C8DD-4D9A-A7E6-DBDD2D787337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440" y="609120"/>
            <a:ext cx="7769160" cy="114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440" y="1981080"/>
            <a:ext cx="379116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6680" y="1981080"/>
            <a:ext cx="379116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65467D7-1DC0-41AE-8985-A67A50730832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440" y="609120"/>
            <a:ext cx="7769160" cy="114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1B35CF5-237C-45FF-A533-259DA49942FD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440" y="609120"/>
            <a:ext cx="7769160" cy="5286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29C0435-B3AA-42CD-A1AC-E62D9D06056B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440" y="609120"/>
            <a:ext cx="7769160" cy="114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440" y="1981080"/>
            <a:ext cx="37911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6680" y="1981080"/>
            <a:ext cx="379116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440" y="4129920"/>
            <a:ext cx="37911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A0287C9-5730-4E21-9554-10E0949C1EC7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440" y="609120"/>
            <a:ext cx="7769160" cy="114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440" y="1981080"/>
            <a:ext cx="379116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6680" y="1981080"/>
            <a:ext cx="37911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6680" y="4129920"/>
            <a:ext cx="37911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2C87337-9CB7-453C-838D-BCF8A98E2E54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440" y="609120"/>
            <a:ext cx="7769160" cy="114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440" y="1981080"/>
            <a:ext cx="37911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6680" y="1981080"/>
            <a:ext cx="37911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440" y="4129920"/>
            <a:ext cx="77691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FD520BA-733A-461C-A5FF-4DBED944A30F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440" y="609120"/>
            <a:ext cx="7769160" cy="114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440" y="1981080"/>
            <a:ext cx="776916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Text Box 3"/>
          <p:cNvSpPr/>
          <p:nvPr/>
        </p:nvSpPr>
        <p:spPr>
          <a:xfrm>
            <a:off x="685800" y="6248520"/>
            <a:ext cx="1905120" cy="46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Text Box 4"/>
          <p:cNvSpPr/>
          <p:nvPr/>
        </p:nvSpPr>
        <p:spPr>
          <a:xfrm>
            <a:off x="3124080" y="6248520"/>
            <a:ext cx="2895840" cy="46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6552720" y="6248520"/>
            <a:ext cx="190188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2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12985634-9FF1-419C-A252-80137EA178AE}" type="slidenum"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1"/>
          <p:cNvGrpSpPr/>
          <p:nvPr/>
        </p:nvGrpSpPr>
        <p:grpSpPr>
          <a:xfrm>
            <a:off x="0" y="304920"/>
            <a:ext cx="8686800" cy="6172200"/>
            <a:chOff x="0" y="304920"/>
            <a:chExt cx="8686800" cy="6172200"/>
          </a:xfrm>
        </p:grpSpPr>
        <p:grpSp>
          <p:nvGrpSpPr>
            <p:cNvPr id="51" name="Group 5"/>
            <p:cNvGrpSpPr/>
            <p:nvPr/>
          </p:nvGrpSpPr>
          <p:grpSpPr>
            <a:xfrm>
              <a:off x="0" y="304920"/>
              <a:ext cx="8686800" cy="6172200"/>
              <a:chOff x="0" y="304920"/>
              <a:chExt cx="8686800" cy="6172200"/>
            </a:xfrm>
          </p:grpSpPr>
          <p:pic>
            <p:nvPicPr>
              <p:cNvPr id="52" name="Picture 3" descr=""/>
              <p:cNvPicPr/>
              <p:nvPr/>
            </p:nvPicPr>
            <p:blipFill>
              <a:blip r:embed="rId1"/>
              <a:stretch/>
            </p:blipFill>
            <p:spPr>
              <a:xfrm>
                <a:off x="152280" y="304920"/>
                <a:ext cx="8534520" cy="5639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3" name="Text Box 2"/>
              <p:cNvSpPr/>
              <p:nvPr/>
            </p:nvSpPr>
            <p:spPr>
              <a:xfrm>
                <a:off x="3429000" y="6085080"/>
                <a:ext cx="3173400" cy="39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720" bIns="45000" anchor="t">
                <a:norm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  <a:tab algn="l" pos="10058400"/>
                    <a:tab algn="l" pos="105156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Normalized gene expression </a:t>
                </a:r>
                <a:endParaRPr b="0" lang="en-US" sz="16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54" name="AutoShape 3"/>
              <p:cNvSpPr/>
              <p:nvPr/>
            </p:nvSpPr>
            <p:spPr>
              <a:xfrm>
                <a:off x="3079800" y="3810240"/>
                <a:ext cx="120600" cy="1704960"/>
              </a:xfrm>
              <a:custGeom>
                <a:avLst/>
                <a:gdLst>
                  <a:gd name="textAreaLeft" fmla="*/ 0 w 120600"/>
                  <a:gd name="textAreaRight" fmla="*/ 43560 w 120600"/>
                  <a:gd name="textAreaTop" fmla="*/ 14760 h 1704960"/>
                  <a:gd name="textAreaBottom" fmla="*/ 1690200 h 17049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303"/>
                      <a:pt x="10800" y="606"/>
                    </a:cubicBezTo>
                    <a:lnTo>
                      <a:pt x="10800" y="10194"/>
                    </a:lnTo>
                    <a:cubicBezTo>
                      <a:pt x="10800" y="10497"/>
                      <a:pt x="16200" y="10800"/>
                      <a:pt x="21600" y="10800"/>
                    </a:cubicBezTo>
                    <a:cubicBezTo>
                      <a:pt x="16200" y="10800"/>
                      <a:pt x="10800" y="11103"/>
                      <a:pt x="10800" y="11406"/>
                    </a:cubicBezTo>
                    <a:lnTo>
                      <a:pt x="10800" y="20994"/>
                    </a:lnTo>
                    <a:cubicBezTo>
                      <a:pt x="10800" y="21297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55" name="Text Box 4"/>
              <p:cNvSpPr/>
              <p:nvPr/>
            </p:nvSpPr>
            <p:spPr>
              <a:xfrm>
                <a:off x="3200400" y="4572360"/>
                <a:ext cx="2643120" cy="323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720" bIns="45000" anchor="t">
                <a:normAutofit fontScale="92000"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  <a:tab algn="l" pos="10058400"/>
                    <a:tab algn="l" pos="105156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Arial"/>
                  </a:rPr>
                  <a:t>House-keeping genes</a:t>
                </a:r>
                <a:endParaRPr b="0" lang="en-US" sz="16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56" name="Line 6"/>
              <p:cNvSpPr/>
              <p:nvPr/>
            </p:nvSpPr>
            <p:spPr>
              <a:xfrm flipV="1">
                <a:off x="1141200" y="5643360"/>
                <a:ext cx="1440" cy="330120"/>
              </a:xfrm>
              <a:prstGeom prst="line">
                <a:avLst/>
              </a:prstGeom>
              <a:ln w="9360">
                <a:solidFill>
                  <a:srgbClr val="333333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57" name="Straight Connector 2"/>
              <p:cNvSpPr/>
              <p:nvPr/>
            </p:nvSpPr>
            <p:spPr>
              <a:xfrm flipH="1">
                <a:off x="7507080" y="5486760"/>
                <a:ext cx="75960" cy="156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58" name="Straight Connector 32"/>
              <p:cNvSpPr/>
              <p:nvPr/>
            </p:nvSpPr>
            <p:spPr>
              <a:xfrm flipH="1">
                <a:off x="7619760" y="5486760"/>
                <a:ext cx="75960" cy="156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59" name="TextBox 4"/>
              <p:cNvSpPr/>
              <p:nvPr/>
            </p:nvSpPr>
            <p:spPr>
              <a:xfrm>
                <a:off x="7425000" y="3319560"/>
                <a:ext cx="3438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</a:rPr>
                  <a:t>/ /</a:t>
                </a:r>
                <a:endParaRPr b="0" lang="en-US" sz="16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grpSp>
            <p:nvGrpSpPr>
              <p:cNvPr id="60" name="Group 5"/>
              <p:cNvGrpSpPr/>
              <p:nvPr/>
            </p:nvGrpSpPr>
            <p:grpSpPr>
              <a:xfrm>
                <a:off x="5105520" y="347760"/>
                <a:ext cx="3505320" cy="2166840"/>
                <a:chOff x="5105520" y="347760"/>
                <a:chExt cx="3505320" cy="2166840"/>
              </a:xfrm>
            </p:grpSpPr>
            <p:grpSp>
              <p:nvGrpSpPr>
                <p:cNvPr id="61" name="Group 20"/>
                <p:cNvGrpSpPr/>
                <p:nvPr/>
              </p:nvGrpSpPr>
              <p:grpSpPr>
                <a:xfrm>
                  <a:off x="5105520" y="1295640"/>
                  <a:ext cx="3441960" cy="1218960"/>
                  <a:chOff x="5105520" y="1295640"/>
                  <a:chExt cx="3441960" cy="1218960"/>
                </a:xfrm>
              </p:grpSpPr>
              <p:sp>
                <p:nvSpPr>
                  <p:cNvPr id="62" name="Text Box 7"/>
                  <p:cNvSpPr/>
                  <p:nvPr/>
                </p:nvSpPr>
                <p:spPr>
                  <a:xfrm>
                    <a:off x="5105520" y="1963800"/>
                    <a:ext cx="3429720" cy="322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54720" bIns="45000" anchor="t">
                    <a:normAutofit fontScale="99000"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  <a:tab algn="l" pos="9601200"/>
                        <a:tab algn="l" pos="10058400"/>
                        <a:tab algn="l" pos="10515600"/>
                      </a:tabLst>
                    </a:pPr>
                    <a:r>
                      <a:rPr b="0" lang="en-US" sz="1400" spc="-1" strike="noStrike">
                        <a:solidFill>
                          <a:srgbClr val="000000"/>
                        </a:solidFill>
                        <a:latin typeface="Arial"/>
                      </a:rPr>
                      <a:t>  </a:t>
                    </a:r>
                    <a:r>
                      <a:rPr b="0" lang="en-US" sz="1400" spc="-1" strike="noStrike">
                        <a:solidFill>
                          <a:srgbClr val="000000"/>
                        </a:solidFill>
                        <a:latin typeface="Arial"/>
                      </a:rPr>
                      <a:t>0.5         1.0          1.5                      ≥ 2.5</a:t>
                    </a:r>
                    <a:endParaRPr b="0" lang="en-US" sz="1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63" name="Text Box 8"/>
                  <p:cNvSpPr/>
                  <p:nvPr/>
                </p:nvSpPr>
                <p:spPr>
                  <a:xfrm>
                    <a:off x="5410080" y="1295640"/>
                    <a:ext cx="2886480" cy="380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54720" bIns="45000" anchor="t">
                    <a:norm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  <a:tab algn="l" pos="9601200"/>
                        <a:tab algn="l" pos="10058400"/>
                        <a:tab algn="l" pos="10515600"/>
                      </a:tabLst>
                    </a:pPr>
                    <a:r>
                      <a:rPr b="0" lang="en-US" sz="1600" spc="-1" strike="noStrike">
                        <a:solidFill>
                          <a:srgbClr val="000000"/>
                        </a:solidFill>
                        <a:latin typeface="Arial"/>
                      </a:rPr>
                      <a:t>WT normalized background</a:t>
                    </a:r>
                    <a:endParaRPr b="0" lang="en-US" sz="16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64" name="Text Box 9"/>
                  <p:cNvSpPr/>
                  <p:nvPr/>
                </p:nvSpPr>
                <p:spPr>
                  <a:xfrm>
                    <a:off x="6240600" y="2192400"/>
                    <a:ext cx="2306880" cy="322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54720" bIns="45000" anchor="t">
                    <a:normAutofit fontScale="91000"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  <a:tab algn="l" pos="9601200"/>
                        <a:tab algn="l" pos="10058400"/>
                        <a:tab algn="l" pos="10515600"/>
                      </a:tabLst>
                    </a:pPr>
                    <a:r>
                      <a:rPr b="0" lang="en-US" sz="1600" spc="-1" strike="noStrike">
                        <a:solidFill>
                          <a:srgbClr val="000000"/>
                        </a:solidFill>
                        <a:latin typeface="Arial"/>
                      </a:rPr>
                      <a:t>Heatmap scale</a:t>
                    </a:r>
                    <a:endParaRPr b="0" lang="en-US" sz="16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pic>
                <p:nvPicPr>
                  <p:cNvPr id="65" name="Picture 1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308560" y="1828800"/>
                    <a:ext cx="3017880" cy="199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66" name="Line 12"/>
                  <p:cNvSpPr/>
                  <p:nvPr/>
                </p:nvSpPr>
                <p:spPr>
                  <a:xfrm>
                    <a:off x="6094440" y="1658880"/>
                    <a:ext cx="1440" cy="1476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</p:grpSp>
            <p:sp>
              <p:nvSpPr>
                <p:cNvPr id="67" name="Rectangle 3"/>
                <p:cNvSpPr/>
                <p:nvPr/>
              </p:nvSpPr>
              <p:spPr>
                <a:xfrm>
                  <a:off x="5562720" y="457560"/>
                  <a:ext cx="3048120" cy="60948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grpSp>
              <p:nvGrpSpPr>
                <p:cNvPr id="68" name="Group 41"/>
                <p:cNvGrpSpPr/>
                <p:nvPr/>
              </p:nvGrpSpPr>
              <p:grpSpPr>
                <a:xfrm>
                  <a:off x="5446080" y="347760"/>
                  <a:ext cx="2850480" cy="718200"/>
                  <a:chOff x="5446080" y="347760"/>
                  <a:chExt cx="2850480" cy="718200"/>
                </a:xfrm>
              </p:grpSpPr>
              <p:sp>
                <p:nvSpPr>
                  <p:cNvPr id="69" name="Rectangle 42"/>
                  <p:cNvSpPr/>
                  <p:nvPr/>
                </p:nvSpPr>
                <p:spPr>
                  <a:xfrm>
                    <a:off x="5446440" y="423720"/>
                    <a:ext cx="228600" cy="228600"/>
                  </a:xfrm>
                  <a:prstGeom prst="rect">
                    <a:avLst/>
                  </a:prstGeom>
                  <a:solidFill>
                    <a:srgbClr val="0070c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70" name="TextBox 43"/>
                  <p:cNvSpPr/>
                  <p:nvPr/>
                </p:nvSpPr>
                <p:spPr>
                  <a:xfrm>
                    <a:off x="5678280" y="347760"/>
                    <a:ext cx="49608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WT</a:t>
                    </a:r>
                    <a:endParaRPr b="0" lang="en-US" sz="16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grpSp>
                <p:nvGrpSpPr>
                  <p:cNvPr id="71" name="Group 44"/>
                  <p:cNvGrpSpPr/>
                  <p:nvPr/>
                </p:nvGrpSpPr>
                <p:grpSpPr>
                  <a:xfrm>
                    <a:off x="5446080" y="728640"/>
                    <a:ext cx="1153440" cy="337320"/>
                    <a:chOff x="5446080" y="728640"/>
                    <a:chExt cx="1153440" cy="337320"/>
                  </a:xfrm>
                </p:grpSpPr>
                <p:sp>
                  <p:nvSpPr>
                    <p:cNvPr id="72" name="Rectangle 50"/>
                    <p:cNvSpPr/>
                    <p:nvPr/>
                  </p:nvSpPr>
                  <p:spPr>
                    <a:xfrm>
                      <a:off x="5446080" y="761760"/>
                      <a:ext cx="228600" cy="228600"/>
                    </a:xfrm>
                    <a:prstGeom prst="rect">
                      <a:avLst/>
                    </a:prstGeom>
                    <a:solidFill>
                      <a:srgbClr val="a7c46e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ffffff"/>
                        </a:solidFill>
                        <a:latin typeface="Times New Roman"/>
                      </a:endParaRPr>
                    </a:p>
                  </p:txBody>
                </p:sp>
                <p:sp>
                  <p:nvSpPr>
                    <p:cNvPr id="73" name="TextBox 51"/>
                    <p:cNvSpPr/>
                    <p:nvPr/>
                  </p:nvSpPr>
                  <p:spPr>
                    <a:xfrm>
                      <a:off x="5688720" y="728640"/>
                      <a:ext cx="910800" cy="3373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X-1</a:t>
                      </a:r>
                      <a:r>
                        <a:rPr b="1" lang="en-US" sz="16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/-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Times New Roman"/>
                      </a:endParaRPr>
                    </a:p>
                  </p:txBody>
                </p:sp>
              </p:grpSp>
              <p:sp>
                <p:nvSpPr>
                  <p:cNvPr id="74" name="Rectangle 45"/>
                  <p:cNvSpPr/>
                  <p:nvPr/>
                </p:nvSpPr>
                <p:spPr>
                  <a:xfrm>
                    <a:off x="6818400" y="423720"/>
                    <a:ext cx="228600" cy="228600"/>
                  </a:xfrm>
                  <a:prstGeom prst="rect">
                    <a:avLst/>
                  </a:prstGeom>
                  <a:solidFill>
                    <a:srgbClr val="ff5d5d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75" name="TextBox 46"/>
                  <p:cNvSpPr/>
                  <p:nvPr/>
                </p:nvSpPr>
                <p:spPr>
                  <a:xfrm>
                    <a:off x="7085520" y="347760"/>
                    <a:ext cx="121104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WT + IL-1</a:t>
                    </a:r>
                    <a:r>
                      <a:rPr b="1" lang="el-GR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β</a:t>
                    </a:r>
                    <a:endParaRPr b="0" lang="en-US" sz="16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grpSp>
                <p:nvGrpSpPr>
                  <p:cNvPr id="76" name="Group 47"/>
                  <p:cNvGrpSpPr/>
                  <p:nvPr/>
                </p:nvGrpSpPr>
                <p:grpSpPr>
                  <a:xfrm>
                    <a:off x="6817680" y="728640"/>
                    <a:ext cx="1153440" cy="337320"/>
                    <a:chOff x="6817680" y="728640"/>
                    <a:chExt cx="1153440" cy="337320"/>
                  </a:xfrm>
                </p:grpSpPr>
                <p:sp>
                  <p:nvSpPr>
                    <p:cNvPr id="77" name="Rectangle 48"/>
                    <p:cNvSpPr/>
                    <p:nvPr/>
                  </p:nvSpPr>
                  <p:spPr>
                    <a:xfrm>
                      <a:off x="6817680" y="761760"/>
                      <a:ext cx="228600" cy="228600"/>
                    </a:xfrm>
                    <a:prstGeom prst="rect">
                      <a:avLst/>
                    </a:prstGeom>
                    <a:solidFill>
                      <a:srgbClr val="9d5bff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ffffff"/>
                        </a:solidFill>
                        <a:latin typeface="Times New Roman"/>
                      </a:endParaRPr>
                    </a:p>
                  </p:txBody>
                </p:sp>
                <p:sp>
                  <p:nvSpPr>
                    <p:cNvPr id="78" name="TextBox 49"/>
                    <p:cNvSpPr/>
                    <p:nvPr/>
                  </p:nvSpPr>
                  <p:spPr>
                    <a:xfrm>
                      <a:off x="7060320" y="728640"/>
                      <a:ext cx="910800" cy="3373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X-2</a:t>
                      </a:r>
                      <a:r>
                        <a:rPr b="1" lang="en-US" sz="16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/-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Times New Roman"/>
                      </a:endParaRPr>
                    </a:p>
                  </p:txBody>
                </p:sp>
              </p:grpSp>
            </p:grpSp>
          </p:grpSp>
          <p:sp>
            <p:nvSpPr>
              <p:cNvPr id="79" name="Rectangle 4"/>
              <p:cNvSpPr/>
              <p:nvPr/>
            </p:nvSpPr>
            <p:spPr>
              <a:xfrm>
                <a:off x="380880" y="1219320"/>
                <a:ext cx="685800" cy="380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IF</a:t>
                </a:r>
                <a:endParaRPr b="0" lang="en-US" sz="16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80" name="Rectangle 32"/>
              <p:cNvSpPr/>
              <p:nvPr/>
            </p:nvSpPr>
            <p:spPr>
              <a:xfrm>
                <a:off x="380880" y="1676520"/>
                <a:ext cx="685800" cy="380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dt</a:t>
                </a:r>
                <a:endParaRPr b="0" lang="en-US" sz="16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81" name="Rectangle 33"/>
              <p:cNvSpPr/>
              <p:nvPr/>
            </p:nvSpPr>
            <p:spPr>
              <a:xfrm>
                <a:off x="228600" y="2133720"/>
                <a:ext cx="838080" cy="380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OX-3</a:t>
                </a:r>
                <a:endParaRPr b="0" lang="en-US" sz="16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82" name="Rectangle 34"/>
              <p:cNvSpPr/>
              <p:nvPr/>
            </p:nvSpPr>
            <p:spPr>
              <a:xfrm>
                <a:off x="228600" y="2514600"/>
                <a:ext cx="838080" cy="380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OX-2</a:t>
                </a:r>
                <a:endParaRPr b="0" lang="en-US" sz="16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83" name="Rectangle 35"/>
              <p:cNvSpPr/>
              <p:nvPr/>
            </p:nvSpPr>
            <p:spPr>
              <a:xfrm>
                <a:off x="228600" y="2971800"/>
                <a:ext cx="838080" cy="380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OX-1</a:t>
                </a:r>
                <a:endParaRPr b="0" lang="en-US" sz="16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84" name="Rectangle 36"/>
              <p:cNvSpPr/>
              <p:nvPr/>
            </p:nvSpPr>
            <p:spPr>
              <a:xfrm>
                <a:off x="228600" y="3353040"/>
                <a:ext cx="838080" cy="380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stt1</a:t>
                </a:r>
                <a:endParaRPr b="0" lang="en-US" sz="16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85" name="Rectangle 37"/>
              <p:cNvSpPr/>
              <p:nvPr/>
            </p:nvSpPr>
            <p:spPr>
              <a:xfrm>
                <a:off x="152280" y="3810240"/>
                <a:ext cx="838080" cy="380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PL30</a:t>
                </a:r>
                <a:endParaRPr b="0" lang="en-US" sz="16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86" name="Rectangle 38"/>
              <p:cNvSpPr/>
              <p:nvPr/>
            </p:nvSpPr>
            <p:spPr>
              <a:xfrm>
                <a:off x="152280" y="4267440"/>
                <a:ext cx="838080" cy="380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SP13</a:t>
                </a:r>
                <a:endParaRPr b="0" lang="en-US" sz="16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87" name="Rectangle 39"/>
              <p:cNvSpPr/>
              <p:nvPr/>
            </p:nvSpPr>
            <p:spPr>
              <a:xfrm>
                <a:off x="0" y="4724640"/>
                <a:ext cx="990360" cy="380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APDH</a:t>
                </a:r>
                <a:endParaRPr b="0" lang="en-US" sz="16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sp>
            <p:nvSpPr>
              <p:cNvPr id="88" name="Rectangle 40"/>
              <p:cNvSpPr/>
              <p:nvPr/>
            </p:nvSpPr>
            <p:spPr>
              <a:xfrm>
                <a:off x="152280" y="5181840"/>
                <a:ext cx="838080" cy="380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ctin</a:t>
                </a:r>
                <a:endParaRPr b="0" lang="en-US" sz="16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</p:grpSp>
        <p:sp>
          <p:nvSpPr>
            <p:cNvPr id="89" name="Straight Connector 2"/>
            <p:cNvSpPr/>
            <p:nvPr/>
          </p:nvSpPr>
          <p:spPr>
            <a:xfrm>
              <a:off x="1371600" y="5543640"/>
              <a:ext cx="59436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90" name="Straight Connector 43"/>
            <p:cNvSpPr/>
            <p:nvPr/>
          </p:nvSpPr>
          <p:spPr>
            <a:xfrm>
              <a:off x="7848720" y="5553360"/>
              <a:ext cx="6858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91" name="Straight Connector 49"/>
            <p:cNvSpPr/>
            <p:nvPr/>
          </p:nvSpPr>
          <p:spPr>
            <a:xfrm flipV="1">
              <a:off x="1371600" y="1218960"/>
              <a:ext cx="0" cy="43434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1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06-03T15:59:54Z</dcterms:created>
  <dc:creator>HJD_USER</dc:creator>
  <dc:description/>
  <dc:language>en-US</dc:language>
  <cp:lastModifiedBy>GPB2014</cp:lastModifiedBy>
  <cp:lastPrinted>2015-04-15T21:48:10Z</cp:lastPrinted>
  <dcterms:modified xsi:type="dcterms:W3CDTF">2017-12-09T02:21:57Z</dcterms:modified>
  <cp:revision>320</cp:revision>
  <dc:subject/>
  <dc:title>PowerPoint Presentation</dc:title>
</cp:coreProperties>
</file>